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92560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44177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2115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44526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76595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65501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11798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3856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13563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45471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09204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0F8C4-044C-4A72-BFD3-774ED348D2E0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E1AC9-40A0-4DAE-9FD2-853516AFD4A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9401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8583" y="834901"/>
            <a:ext cx="6702482" cy="502460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199" y="843214"/>
            <a:ext cx="5079819" cy="502460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322" y="515446"/>
            <a:ext cx="72320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>
                <a:cs typeface="+mj-cs"/>
              </a:rPr>
              <a:t>A.</a:t>
            </a:r>
            <a:endParaRPr lang="he-IL" dirty="0">
              <a:cs typeface="+mj-cs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237018" y="490508"/>
            <a:ext cx="72320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>
                <a:cs typeface="+mj-cs"/>
              </a:rPr>
              <a:t>B.</a:t>
            </a:r>
            <a:endParaRPr lang="he-IL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9641452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89955" y="1855494"/>
            <a:ext cx="10681855" cy="36625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wo KEGG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30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athways maps derived from the transcriptomic data according to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oa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o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genome.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KEGG pathway diagram of glutathione metabolism (loa00480) with differentially expressed genes (DEG) indicated. </a:t>
            </a:r>
            <a:r>
              <a:rPr lang="en-US" b="1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KEGG pathway map of the WNT signaling pathway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loa04310)</a:t>
            </a:r>
            <a:r>
              <a:rPr lang="en-US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ith DEG indicated. </a:t>
            </a:r>
            <a:r>
              <a:rPr lang="en-US" sz="2000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een-colored boxes indicate genes previously identified in the </a:t>
            </a:r>
            <a:r>
              <a:rPr lang="en-US" sz="2000" i="1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oa </a:t>
            </a:r>
            <a:r>
              <a:rPr lang="en-US" sz="2000" i="1" dirty="0" err="1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oa</a:t>
            </a:r>
            <a:r>
              <a:rPr lang="en-US" sz="2000" i="1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genome. Red boxes indicate upregulated DEG, and blue boxes downregulated DEG in </a:t>
            </a:r>
            <a:r>
              <a:rPr lang="en-US" sz="2000" i="1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. </a:t>
            </a:r>
            <a:r>
              <a:rPr lang="en-US" sz="2000" i="1" dirty="0" err="1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vanica</a:t>
            </a:r>
            <a:r>
              <a:rPr lang="en-US" sz="2000" i="1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solidFill>
                  <a:srgbClr val="33333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anscriptome following 9-HOT exposure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2806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3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gal Brown Miyara</dc:creator>
  <cp:lastModifiedBy>Sigal Brown Miyara</cp:lastModifiedBy>
  <cp:revision>2</cp:revision>
  <dcterms:created xsi:type="dcterms:W3CDTF">2020-09-24T06:44:21Z</dcterms:created>
  <dcterms:modified xsi:type="dcterms:W3CDTF">2020-12-11T20:59:18Z</dcterms:modified>
</cp:coreProperties>
</file>